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1" r:id="rId2"/>
    <p:sldId id="273" r:id="rId3"/>
    <p:sldId id="274" r:id="rId4"/>
    <p:sldId id="275" r:id="rId5"/>
    <p:sldId id="276" r:id="rId6"/>
    <p:sldId id="272" r:id="rId7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930" y="4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A36534-DC1F-496E-984E-70CC859C1247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2B289-43E5-411E-9E4E-173A8EAD45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958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1/5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B1F4930-B7A5-49B5-B0A5-26C861DC28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5776" y="923327"/>
            <a:ext cx="5950212" cy="5011346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441FFA3-3177-443A-83F3-40320C785E80}"/>
              </a:ext>
            </a:extLst>
          </p:cNvPr>
          <p:cNvSpPr/>
          <p:nvPr/>
        </p:nvSpPr>
        <p:spPr>
          <a:xfrm>
            <a:off x="4130394" y="1955707"/>
            <a:ext cx="3681965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</a:t>
            </a:r>
            <a:r>
              <a:rPr lang="en-US" altLang="ja-JP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rgeted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apy (-) (n=22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.1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10.9-17.3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7C6D5F-8264-4D1F-9AE4-2B6A1BA28150}"/>
              </a:ext>
            </a:extLst>
          </p:cNvPr>
          <p:cNvSpPr txBox="1"/>
          <p:nvPr/>
        </p:nvSpPr>
        <p:spPr>
          <a:xfrm flipH="1">
            <a:off x="575204" y="4147854"/>
            <a:ext cx="3708763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</a:t>
            </a:r>
            <a:r>
              <a:rPr lang="en-US" altLang="ja-JP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rgeted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apy (+) (n=13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.2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0.0-15.0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26C7D1A-68FA-408F-8364-1F3023B0BE6E}"/>
              </a:ext>
            </a:extLst>
          </p:cNvPr>
          <p:cNvSpPr/>
          <p:nvPr/>
        </p:nvSpPr>
        <p:spPr>
          <a:xfrm>
            <a:off x="5530882" y="3917917"/>
            <a:ext cx="962123" cy="36933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59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2FD9DE9-8D38-4B6A-B36D-83F144480528}"/>
              </a:ext>
            </a:extLst>
          </p:cNvPr>
          <p:cNvSpPr/>
          <p:nvPr/>
        </p:nvSpPr>
        <p:spPr>
          <a:xfrm>
            <a:off x="2702742" y="5577321"/>
            <a:ext cx="5019323" cy="64633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Progression-Free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CD9CBF5-3686-476F-B397-F83BA12363C0}"/>
              </a:ext>
            </a:extLst>
          </p:cNvPr>
          <p:cNvSpPr/>
          <p:nvPr/>
        </p:nvSpPr>
        <p:spPr>
          <a:xfrm>
            <a:off x="7362137" y="2615047"/>
            <a:ext cx="1143851" cy="1487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9CC8984-2FCB-49BC-9014-80A24C192E7E}"/>
              </a:ext>
            </a:extLst>
          </p:cNvPr>
          <p:cNvSpPr/>
          <p:nvPr/>
        </p:nvSpPr>
        <p:spPr>
          <a:xfrm>
            <a:off x="3540312" y="173128"/>
            <a:ext cx="334418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32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1</a:t>
            </a:r>
            <a:endParaRPr lang="ja-JP" altLang="en-US" sz="3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8120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EABE87D-211F-4C75-A3DB-00CB643C14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7744" y="923327"/>
            <a:ext cx="5950212" cy="501134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1218BCF-4FFF-45A3-8BA4-BA54C9AF7363}"/>
              </a:ext>
            </a:extLst>
          </p:cNvPr>
          <p:cNvSpPr txBox="1"/>
          <p:nvPr/>
        </p:nvSpPr>
        <p:spPr>
          <a:xfrm flipH="1">
            <a:off x="4194647" y="1656986"/>
            <a:ext cx="3187176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(+) (n=14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.1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8.6-19.5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58C95A1-22DF-4366-89C8-24DE9E1800B5}"/>
              </a:ext>
            </a:extLst>
          </p:cNvPr>
          <p:cNvSpPr/>
          <p:nvPr/>
        </p:nvSpPr>
        <p:spPr>
          <a:xfrm>
            <a:off x="823194" y="4047943"/>
            <a:ext cx="3125599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(-) (n=21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.0 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6.8-15.2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456FED2-E4A4-4A64-B6C9-39CFDD176587}"/>
              </a:ext>
            </a:extLst>
          </p:cNvPr>
          <p:cNvSpPr/>
          <p:nvPr/>
        </p:nvSpPr>
        <p:spPr>
          <a:xfrm>
            <a:off x="5311890" y="3641696"/>
            <a:ext cx="962123" cy="369332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=0.375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7BAD9B5-F893-475F-93BA-5EFCE4F88894}"/>
              </a:ext>
            </a:extLst>
          </p:cNvPr>
          <p:cNvSpPr/>
          <p:nvPr/>
        </p:nvSpPr>
        <p:spPr>
          <a:xfrm>
            <a:off x="2362500" y="5735150"/>
            <a:ext cx="5019323" cy="64633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Progression-Free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9A66584-6F88-4D44-A7B9-ED0C847A38AC}"/>
              </a:ext>
            </a:extLst>
          </p:cNvPr>
          <p:cNvSpPr/>
          <p:nvPr/>
        </p:nvSpPr>
        <p:spPr>
          <a:xfrm>
            <a:off x="7025612" y="2426960"/>
            <a:ext cx="1277391" cy="1124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6E79C63-1E8C-4EA2-A515-89856B1B58D6}"/>
              </a:ext>
            </a:extLst>
          </p:cNvPr>
          <p:cNvSpPr/>
          <p:nvPr/>
        </p:nvSpPr>
        <p:spPr>
          <a:xfrm>
            <a:off x="2903938" y="383652"/>
            <a:ext cx="334418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2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5296514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77354204-DA93-4C22-B5DD-1B13BFDF7E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836712"/>
            <a:ext cx="6454184" cy="543184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A636459-4E21-4511-B9FD-74CBA85D9186}"/>
              </a:ext>
            </a:extLst>
          </p:cNvPr>
          <p:cNvSpPr/>
          <p:nvPr/>
        </p:nvSpPr>
        <p:spPr>
          <a:xfrm>
            <a:off x="2350993" y="5737340"/>
            <a:ext cx="5019323" cy="64633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Progression-Free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A4F2BFA-AD78-4C2D-9C1C-B04113C66C60}"/>
              </a:ext>
            </a:extLst>
          </p:cNvPr>
          <p:cNvSpPr/>
          <p:nvPr/>
        </p:nvSpPr>
        <p:spPr>
          <a:xfrm>
            <a:off x="7370316" y="1062606"/>
            <a:ext cx="1172095" cy="1005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0516855-DA26-4B5D-89AA-E5C36B50E9E5}"/>
              </a:ext>
            </a:extLst>
          </p:cNvPr>
          <p:cNvSpPr/>
          <p:nvPr/>
        </p:nvSpPr>
        <p:spPr>
          <a:xfrm>
            <a:off x="5055179" y="3476432"/>
            <a:ext cx="962123" cy="369332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=0.071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821CB8A-5FB0-4C7E-B0D0-CB9656B4B6AE}"/>
              </a:ext>
            </a:extLst>
          </p:cNvPr>
          <p:cNvSpPr txBox="1"/>
          <p:nvPr/>
        </p:nvSpPr>
        <p:spPr>
          <a:xfrm flipH="1">
            <a:off x="4080152" y="2144233"/>
            <a:ext cx="3290164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A (+) (n=9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.7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11.6-41.8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EE8FCAA-211C-43A4-939C-4A4B49EC30D3}"/>
              </a:ext>
            </a:extLst>
          </p:cNvPr>
          <p:cNvSpPr/>
          <p:nvPr/>
        </p:nvSpPr>
        <p:spPr>
          <a:xfrm>
            <a:off x="893995" y="4295926"/>
            <a:ext cx="3134191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A(-) (n=26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.2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6.6-13.9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E6ECB3E-0193-45AF-9877-E969787305A5}"/>
              </a:ext>
            </a:extLst>
          </p:cNvPr>
          <p:cNvSpPr/>
          <p:nvPr/>
        </p:nvSpPr>
        <p:spPr>
          <a:xfrm>
            <a:off x="6853300" y="1177724"/>
            <a:ext cx="1288011" cy="928468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19FBE52-C359-4726-A279-D04AFF239FEE}"/>
              </a:ext>
            </a:extLst>
          </p:cNvPr>
          <p:cNvSpPr/>
          <p:nvPr/>
        </p:nvSpPr>
        <p:spPr>
          <a:xfrm>
            <a:off x="2917686" y="251937"/>
            <a:ext cx="370426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32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3</a:t>
            </a:r>
            <a:endParaRPr lang="ja-JP" altLang="en-US" sz="3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28855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07CC1A2A-8E7F-4049-9212-C20EC19A08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1052736"/>
            <a:ext cx="5953125" cy="5010150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2995D70-9ECB-4F46-A955-B886EBCA81EA}"/>
              </a:ext>
            </a:extLst>
          </p:cNvPr>
          <p:cNvSpPr/>
          <p:nvPr/>
        </p:nvSpPr>
        <p:spPr>
          <a:xfrm>
            <a:off x="4850243" y="2108501"/>
            <a:ext cx="3657411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</a:t>
            </a:r>
            <a:r>
              <a:rPr lang="en-US" altLang="ja-JP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rgeted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apy (-) (n=22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2.2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33.8-70.5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FDBAFB-E5A4-45D8-8463-FA91D3603565}"/>
              </a:ext>
            </a:extLst>
          </p:cNvPr>
          <p:cNvSpPr txBox="1"/>
          <p:nvPr/>
        </p:nvSpPr>
        <p:spPr>
          <a:xfrm flipH="1">
            <a:off x="963726" y="4091559"/>
            <a:ext cx="3680281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</a:t>
            </a:r>
            <a:r>
              <a:rPr lang="en-US" altLang="ja-JP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rgeted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apy (+) (n=13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.0 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17.5-30.5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3687FE3-69CF-4559-A422-0B3FA085ABF4}"/>
              </a:ext>
            </a:extLst>
          </p:cNvPr>
          <p:cNvSpPr/>
          <p:nvPr/>
        </p:nvSpPr>
        <p:spPr>
          <a:xfrm>
            <a:off x="5545202" y="4414725"/>
            <a:ext cx="962123" cy="369332"/>
          </a:xfrm>
          <a:prstGeom prst="rect">
            <a:avLst/>
          </a:prstGeom>
          <a:ln w="12700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08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8D92B34-A237-40CB-AF3E-AA6A5ABAD50B}"/>
              </a:ext>
            </a:extLst>
          </p:cNvPr>
          <p:cNvSpPr/>
          <p:nvPr/>
        </p:nvSpPr>
        <p:spPr>
          <a:xfrm>
            <a:off x="3255416" y="5732804"/>
            <a:ext cx="3411853" cy="64633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Overall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20E60CE-1A3B-4DD9-B953-FDEE5FAEB98D}"/>
              </a:ext>
            </a:extLst>
          </p:cNvPr>
          <p:cNvSpPr/>
          <p:nvPr/>
        </p:nvSpPr>
        <p:spPr>
          <a:xfrm>
            <a:off x="7159502" y="4896186"/>
            <a:ext cx="1277391" cy="9421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1C5E8D05-05A6-4E48-8A4B-34C4AFCDB894}"/>
              </a:ext>
            </a:extLst>
          </p:cNvPr>
          <p:cNvSpPr/>
          <p:nvPr/>
        </p:nvSpPr>
        <p:spPr>
          <a:xfrm>
            <a:off x="3289251" y="343865"/>
            <a:ext cx="334418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32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4</a:t>
            </a:r>
            <a:endParaRPr lang="ja-JP" altLang="en-US" sz="3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27105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45BEC5DF-B871-4867-975C-F2AD386495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1760" y="1268760"/>
            <a:ext cx="5953125" cy="5010150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AA8041B-6402-48CC-A694-22B1BCC21D1B}"/>
              </a:ext>
            </a:extLst>
          </p:cNvPr>
          <p:cNvSpPr txBox="1"/>
          <p:nvPr/>
        </p:nvSpPr>
        <p:spPr>
          <a:xfrm flipH="1">
            <a:off x="4326229" y="2020382"/>
            <a:ext cx="3342115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(+) (n=14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2.2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2.3-102.0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DF18936-A862-4DE6-8F45-CE21A290F2C6}"/>
              </a:ext>
            </a:extLst>
          </p:cNvPr>
          <p:cNvSpPr/>
          <p:nvPr/>
        </p:nvSpPr>
        <p:spPr>
          <a:xfrm>
            <a:off x="1940825" y="4172611"/>
            <a:ext cx="3279247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emotherapy (-) (n=21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.0 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21.2-63.2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F5D2334-DCC5-44E0-B932-E66670B051F9}"/>
              </a:ext>
            </a:extLst>
          </p:cNvPr>
          <p:cNvSpPr/>
          <p:nvPr/>
        </p:nvSpPr>
        <p:spPr>
          <a:xfrm>
            <a:off x="5388322" y="3244334"/>
            <a:ext cx="962123" cy="36933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998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817087B-9B06-4FC1-B7AF-E5721A6DD4BE}"/>
              </a:ext>
            </a:extLst>
          </p:cNvPr>
          <p:cNvSpPr/>
          <p:nvPr/>
        </p:nvSpPr>
        <p:spPr>
          <a:xfrm>
            <a:off x="3155792" y="5841032"/>
            <a:ext cx="3619670" cy="64633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Overall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99AE2AB-C09B-4C07-A7E9-EEC26D15E83F}"/>
              </a:ext>
            </a:extLst>
          </p:cNvPr>
          <p:cNvSpPr/>
          <p:nvPr/>
        </p:nvSpPr>
        <p:spPr>
          <a:xfrm>
            <a:off x="7184475" y="4690470"/>
            <a:ext cx="1277391" cy="9421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FC0C37DA-B218-4C82-B494-B68C29E8B3CA}"/>
              </a:ext>
            </a:extLst>
          </p:cNvPr>
          <p:cNvSpPr/>
          <p:nvPr/>
        </p:nvSpPr>
        <p:spPr>
          <a:xfrm>
            <a:off x="3059822" y="423694"/>
            <a:ext cx="334418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32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5</a:t>
            </a:r>
            <a:endParaRPr lang="ja-JP" altLang="en-US" sz="3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619199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99AE7469-830F-45B5-AAB4-AB49CB1DF7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7744" y="980728"/>
            <a:ext cx="5953125" cy="5010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5752132-4710-4409-977D-1066787B443B}"/>
              </a:ext>
            </a:extLst>
          </p:cNvPr>
          <p:cNvSpPr/>
          <p:nvPr/>
        </p:nvSpPr>
        <p:spPr>
          <a:xfrm>
            <a:off x="3304974" y="5668513"/>
            <a:ext cx="3249608" cy="646331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3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Overall Survival</a:t>
            </a:r>
            <a:endParaRPr lang="ja-JP" altLang="en-US" sz="3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DFF31CB-A1B0-4993-B906-B9075CDE8DEF}"/>
              </a:ext>
            </a:extLst>
          </p:cNvPr>
          <p:cNvSpPr/>
          <p:nvPr/>
        </p:nvSpPr>
        <p:spPr>
          <a:xfrm>
            <a:off x="7048774" y="2180500"/>
            <a:ext cx="1172095" cy="10058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E3DA37B-9504-4126-A896-DCF661AD6A01}"/>
              </a:ext>
            </a:extLst>
          </p:cNvPr>
          <p:cNvSpPr/>
          <p:nvPr/>
        </p:nvSpPr>
        <p:spPr>
          <a:xfrm>
            <a:off x="5339508" y="3301137"/>
            <a:ext cx="962123" cy="36933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84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AAB76A4-3906-4AAE-B6D1-CC34D84CEAD7}"/>
              </a:ext>
            </a:extLst>
          </p:cNvPr>
          <p:cNvSpPr txBox="1"/>
          <p:nvPr/>
        </p:nvSpPr>
        <p:spPr>
          <a:xfrm flipH="1">
            <a:off x="4707181" y="1956266"/>
            <a:ext cx="1594450" cy="646331"/>
          </a:xfrm>
          <a:prstGeom prst="rect">
            <a:avLst/>
          </a:prstGeom>
          <a:ln w="19050"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A (+) (n=9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 reached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2DB697D-C0DD-48CE-A5A8-B2BCCC81F879}"/>
              </a:ext>
            </a:extLst>
          </p:cNvPr>
          <p:cNvSpPr/>
          <p:nvPr/>
        </p:nvSpPr>
        <p:spPr>
          <a:xfrm>
            <a:off x="1441270" y="3625103"/>
            <a:ext cx="3249608" cy="646331"/>
          </a:xfrm>
          <a:prstGeom prst="rect">
            <a:avLst/>
          </a:prstGeom>
          <a:ln w="19050"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A(-) (n=26)</a:t>
            </a:r>
          </a:p>
          <a:p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.8</a:t>
            </a:r>
            <a:r>
              <a:rPr kumimoji="1"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onths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95%C.I. 17.4-70.9)</a:t>
            </a:r>
            <a:endParaRPr lang="ja-JP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954A18B-4EFD-4E4A-A1BE-84D5FC25420E}"/>
              </a:ext>
            </a:extLst>
          </p:cNvPr>
          <p:cNvSpPr/>
          <p:nvPr/>
        </p:nvSpPr>
        <p:spPr>
          <a:xfrm>
            <a:off x="3210397" y="250038"/>
            <a:ext cx="334418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ja-JP" sz="3200" dirty="0">
                <a:solidFill>
                  <a:prstClr val="black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Online Resource. 6</a:t>
            </a:r>
            <a:endParaRPr lang="ja-JP" altLang="en-US" sz="3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361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189</Words>
  <Application>Microsoft Office PowerPoint</Application>
  <PresentationFormat>画面に合わせる (4:3)</PresentationFormat>
  <Paragraphs>42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ＭＳ Ｐゴシック</vt:lpstr>
      <vt:lpstr>游ゴシック</vt:lpstr>
      <vt:lpstr>游明朝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koba</dc:creator>
  <cp:lastModifiedBy>noritokoba@outlook.jp</cp:lastModifiedBy>
  <cp:revision>26</cp:revision>
  <dcterms:created xsi:type="dcterms:W3CDTF">2021-03-26T08:38:16Z</dcterms:created>
  <dcterms:modified xsi:type="dcterms:W3CDTF">2021-05-23T12:57:56Z</dcterms:modified>
</cp:coreProperties>
</file>